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8" d="100"/>
          <a:sy n="118" d="100"/>
        </p:scale>
        <p:origin x="-1482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566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163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765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601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612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277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078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543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124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940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690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C4B3FF-6B19-4AC5-B2F1-AC3D81EFEAC0}" type="datetimeFigureOut">
              <a:rPr lang="en-US" smtClean="0"/>
              <a:t>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3E4019-FD76-4C86-A1C1-035B0DCB52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052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67053" y="5276960"/>
            <a:ext cx="877472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itional fil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: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kage disequilibrium (LD) decay in 822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rciano-Granadin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oats with available Goat SNP50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adChip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otypes. The scatter plot shows the decline of r</a:t>
            </a:r>
            <a:r>
              <a:rPr lang="en-US" altLang="zh-CN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etween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ngle nucleotid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morphisms (y-axis) with distance expressed in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x-axis)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ting line is depicted in red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932" y="345501"/>
            <a:ext cx="7253654" cy="48012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6057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8</TotalTime>
  <Words>55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ilu Guan</dc:creator>
  <cp:lastModifiedBy>ma</cp:lastModifiedBy>
  <cp:revision>4</cp:revision>
  <dcterms:created xsi:type="dcterms:W3CDTF">2019-12-30T09:53:09Z</dcterms:created>
  <dcterms:modified xsi:type="dcterms:W3CDTF">2020-01-14T18:30:33Z</dcterms:modified>
</cp:coreProperties>
</file>